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63" r:id="rId2"/>
    <p:sldId id="303" r:id="rId3"/>
    <p:sldId id="309" r:id="rId4"/>
    <p:sldId id="308" r:id="rId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157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59" d="100"/>
          <a:sy n="59" d="100"/>
        </p:scale>
        <p:origin x="868" y="56"/>
      </p:cViewPr>
      <p:guideLst>
        <p:guide orient="horz" pos="2160"/>
        <p:guide pos="1572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5D03985-ECA4-4458-8CDA-7B2343EBB03B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0CBF7B9-0935-4716-88EB-F6FDD2C257B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371281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0CBF7B9-0935-4716-88EB-F6FDD2C257B9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4281245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93420B3-2007-8945-2CA2-440828B92C0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4A74C812-32CC-D42B-2ED3-5059D7B9866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3A0B976-D15F-63B3-3477-FA6D27A754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A2886-9E53-4F9A-B1B0-B2BF18E5579F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32899AD-DA07-DB4B-1DDD-27E9B2006A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3F4EAA0-DE84-386B-D6CA-6499B17297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695DD-719A-4FBD-97F1-46FE45EDF2E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654238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5A73C08-93FD-A72F-35A8-728C44D305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40A2441-89FA-7ACE-7385-4FACE66555C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AFF15CF-BB02-A4A7-0184-B6DA5C5192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A2886-9E53-4F9A-B1B0-B2BF18E5579F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26C99A8-2B14-09AA-FF0D-3C7EC187B8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91CAFCC-4719-221B-4746-B6E156EDEA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695DD-719A-4FBD-97F1-46FE45EDF2E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243600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49F297DD-0E81-58E4-BD6D-FA8F7C33D0F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A1C0C99-46F9-6994-1DF9-47711D7E09D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F6B2843-C843-8F51-7CE3-D1AB8BCD23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A2886-9E53-4F9A-B1B0-B2BF18E5579F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34D9AAE-A254-AB98-6F80-341C85C135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0156789-8C5E-80E7-9636-F9109414B6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695DD-719A-4FBD-97F1-46FE45EDF2E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853076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19E7232-F2B1-7A43-7B54-2831610144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AF124F1-FF2D-29D8-BEF2-49E0581D7F7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71C22EA-B0F2-B9F4-DB90-825872F63F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A2886-9E53-4F9A-B1B0-B2BF18E5579F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1238766-C657-5561-CD68-A6AEDD1DE4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3BF2083-D78D-3EC9-FE9D-CEA84A0B97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695DD-719A-4FBD-97F1-46FE45EDF2E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402391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EA28525-CB37-5C97-610D-F1D63285BD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3AE1BB7-2171-0475-A5D3-72B0C1084B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EE6377E-4EAE-DA90-78C4-6F3628F70A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A2886-9E53-4F9A-B1B0-B2BF18E5579F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D46CF1C-6E6C-A801-35EC-B028C7C5DB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9D070E0-831A-36B2-8F5D-52A09C54B8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695DD-719A-4FBD-97F1-46FE45EDF2E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17154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77BD8B6-47BA-77F0-C73F-E7CAB9CD39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B910286-F9E5-6883-3D3D-03C631909A0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13A0F13-2564-E7C8-061E-85863298BA8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140AF21-8069-7201-0EEC-7B3C98D3A3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A2886-9E53-4F9A-B1B0-B2BF18E5579F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67B770C-B801-00A8-6804-09D24CEBDE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A2CCA42-F32E-AC7B-6E2F-5EA292FDC5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695DD-719A-4FBD-97F1-46FE45EDF2E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478826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0756C08-8DD1-B9EE-DD57-4059F721F0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DF8BD0D-C757-2B7C-C0C4-11A8529DE8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B79B23B3-C4B7-DE5E-8F09-1AB5D474624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00B291B1-AC61-17A7-CE49-59DEACB9B67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1A07A239-4EF5-DD94-6CEE-F31B53E149F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4215DF10-8C33-1A43-F481-98FEC531DF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A2886-9E53-4F9A-B1B0-B2BF18E5579F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B401914A-DB1E-BE92-0A9F-D82D89A9A3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004EDE7D-DC15-7947-3217-E2203DC2A7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695DD-719A-4FBD-97F1-46FE45EDF2E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213810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28491F3-ADFA-32CB-BFB4-B6EBD57BE1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D82DFD10-010F-830D-DFE1-882230FBF3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A2886-9E53-4F9A-B1B0-B2BF18E5579F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89AE2F00-4679-3035-A568-65C3299798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FD1A058F-F162-27C2-078C-B283474572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695DD-719A-4FBD-97F1-46FE45EDF2E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781032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16F9AFA5-26E5-4D88-4767-5AA215C04F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A2886-9E53-4F9A-B1B0-B2BF18E5579F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F85B8470-64C1-CF69-ADB4-25433C0A9C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C63E63DA-A792-8CAF-DB8E-AFE8872677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695DD-719A-4FBD-97F1-46FE45EDF2E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885407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A046136-2C2D-4692-37BD-021028616F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30E0DD3-BAEB-CD62-F214-D9DE4486611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2C863914-1D8D-94F7-C24F-3B5D172FA6E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308F3D6-B555-04D7-D823-8E9ADA94A6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A2886-9E53-4F9A-B1B0-B2BF18E5579F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4540D10-76E0-8A37-1601-791A57CE70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683F64F-6D5F-9FB6-89C0-E3604C47C9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695DD-719A-4FBD-97F1-46FE45EDF2E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55638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12DA303-9C76-0AF3-7324-711BD3E92C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548F3E01-08BC-C02C-8C1C-4E74A2DD523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FF68AEE-CBCD-9808-CC23-ADA46C8F175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669C709-1ABE-DADC-EEE9-94382B8B67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A2886-9E53-4F9A-B1B0-B2BF18E5579F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47ADBAF-586D-BC0B-A0BD-387677AEF7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0621609-75BA-91FD-933C-3B45D98C25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695DD-719A-4FBD-97F1-46FE45EDF2E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101765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69E1D772-9662-646B-5C21-02A3874659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B9E1169-DB1E-5D3F-FB53-C6C214428E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BCB68BB-73CB-F633-19B8-5AED29D7002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EA2886-9E53-4F9A-B1B0-B2BF18E5579F}" type="datetimeFigureOut">
              <a:rPr lang="zh-CN" altLang="en-US" smtClean="0"/>
              <a:t>2023/4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A39C873-63FF-E048-745B-617C62F85B6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9464E55-7B94-A031-BA84-05BB3026C00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B695DD-719A-4FBD-97F1-46FE45EDF2E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722039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组合 20">
            <a:extLst>
              <a:ext uri="{FF2B5EF4-FFF2-40B4-BE49-F238E27FC236}">
                <a16:creationId xmlns:a16="http://schemas.microsoft.com/office/drawing/2014/main" id="{8C5684F2-6E2E-48BF-BDEE-C1164A3B9CA8}"/>
              </a:ext>
            </a:extLst>
          </p:cNvPr>
          <p:cNvGrpSpPr/>
          <p:nvPr/>
        </p:nvGrpSpPr>
        <p:grpSpPr>
          <a:xfrm>
            <a:off x="303948" y="930302"/>
            <a:ext cx="11393274" cy="3718372"/>
            <a:chOff x="479376" y="1968439"/>
            <a:chExt cx="11120135" cy="3629228"/>
          </a:xfrm>
        </p:grpSpPr>
        <p:grpSp>
          <p:nvGrpSpPr>
            <p:cNvPr id="2" name="组合 1">
              <a:extLst>
                <a:ext uri="{FF2B5EF4-FFF2-40B4-BE49-F238E27FC236}">
                  <a16:creationId xmlns:a16="http://schemas.microsoft.com/office/drawing/2014/main" id="{3340218F-DA89-45F3-AA6B-C9AB84830937}"/>
                </a:ext>
              </a:extLst>
            </p:cNvPr>
            <p:cNvGrpSpPr/>
            <p:nvPr/>
          </p:nvGrpSpPr>
          <p:grpSpPr>
            <a:xfrm>
              <a:off x="479376" y="1968439"/>
              <a:ext cx="3999583" cy="3553353"/>
              <a:chOff x="954663" y="1970402"/>
              <a:chExt cx="3999583" cy="3553353"/>
            </a:xfrm>
          </p:grpSpPr>
          <p:pic>
            <p:nvPicPr>
              <p:cNvPr id="5" name="图片 4">
                <a:extLst>
                  <a:ext uri="{FF2B5EF4-FFF2-40B4-BE49-F238E27FC236}">
                    <a16:creationId xmlns:a16="http://schemas.microsoft.com/office/drawing/2014/main" id="{9F7AE1D7-61A4-484D-A0A3-7560AAAB5A2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54663" y="1981897"/>
                <a:ext cx="3952625" cy="2927643"/>
              </a:xfrm>
              <a:prstGeom prst="rect">
                <a:avLst/>
              </a:prstGeom>
            </p:spPr>
          </p:pic>
          <p:grpSp>
            <p:nvGrpSpPr>
              <p:cNvPr id="6" name="组合 5">
                <a:extLst>
                  <a:ext uri="{FF2B5EF4-FFF2-40B4-BE49-F238E27FC236}">
                    <a16:creationId xmlns:a16="http://schemas.microsoft.com/office/drawing/2014/main" id="{2C54BE55-AA2E-4678-AD2B-4F39232FDC0D}"/>
                  </a:ext>
                </a:extLst>
              </p:cNvPr>
              <p:cNvGrpSpPr/>
              <p:nvPr/>
            </p:nvGrpSpPr>
            <p:grpSpPr>
              <a:xfrm>
                <a:off x="2401354" y="1970402"/>
                <a:ext cx="2552892" cy="1305210"/>
                <a:chOff x="2660072" y="372510"/>
                <a:chExt cx="3962400" cy="2025845"/>
              </a:xfrm>
            </p:grpSpPr>
            <p:cxnSp>
              <p:nvCxnSpPr>
                <p:cNvPr id="8" name="直接连接符 7">
                  <a:extLst>
                    <a:ext uri="{FF2B5EF4-FFF2-40B4-BE49-F238E27FC236}">
                      <a16:creationId xmlns:a16="http://schemas.microsoft.com/office/drawing/2014/main" id="{FC34DA61-6C54-441B-9D25-2D1B59A3E69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660072" y="408823"/>
                  <a:ext cx="2092035" cy="1971688"/>
                </a:xfrm>
                <a:prstGeom prst="line">
                  <a:avLst/>
                </a:prstGeom>
                <a:ln w="22225">
                  <a:solidFill>
                    <a:schemeClr val="tx1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" name="直接连接符 8">
                  <a:extLst>
                    <a:ext uri="{FF2B5EF4-FFF2-40B4-BE49-F238E27FC236}">
                      <a16:creationId xmlns:a16="http://schemas.microsoft.com/office/drawing/2014/main" id="{600DE1B3-A54E-44B3-B220-C5D22736A8B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761344" y="2398355"/>
                  <a:ext cx="1861128" cy="0"/>
                </a:xfrm>
                <a:prstGeom prst="line">
                  <a:avLst/>
                </a:prstGeom>
                <a:ln w="22225">
                  <a:solidFill>
                    <a:schemeClr val="tx1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" name="直接连接符 9">
                  <a:extLst>
                    <a:ext uri="{FF2B5EF4-FFF2-40B4-BE49-F238E27FC236}">
                      <a16:creationId xmlns:a16="http://schemas.microsoft.com/office/drawing/2014/main" id="{9646E9D6-3275-4B98-9B8B-CA5C56C66F3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660072" y="381116"/>
                  <a:ext cx="3962400" cy="0"/>
                </a:xfrm>
                <a:prstGeom prst="line">
                  <a:avLst/>
                </a:prstGeom>
                <a:ln w="22225">
                  <a:solidFill>
                    <a:schemeClr val="tx1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" name="直接连接符 10">
                  <a:extLst>
                    <a:ext uri="{FF2B5EF4-FFF2-40B4-BE49-F238E27FC236}">
                      <a16:creationId xmlns:a16="http://schemas.microsoft.com/office/drawing/2014/main" id="{9CB29A80-D8AD-4454-AD95-E3BAC467C44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622472" y="372510"/>
                  <a:ext cx="0" cy="2008003"/>
                </a:xfrm>
                <a:prstGeom prst="line">
                  <a:avLst/>
                </a:prstGeom>
                <a:ln w="22225">
                  <a:solidFill>
                    <a:schemeClr val="tx1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7" name="文本框 6">
                <a:extLst>
                  <a:ext uri="{FF2B5EF4-FFF2-40B4-BE49-F238E27FC236}">
                    <a16:creationId xmlns:a16="http://schemas.microsoft.com/office/drawing/2014/main" id="{7AD869AF-02B9-4269-9AB2-ADDFB6177110}"/>
                  </a:ext>
                </a:extLst>
              </p:cNvPr>
              <p:cNvSpPr txBox="1"/>
              <p:nvPr/>
            </p:nvSpPr>
            <p:spPr>
              <a:xfrm>
                <a:off x="1788838" y="5163277"/>
                <a:ext cx="455603" cy="36047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dirty="0">
                    <a:latin typeface="Arial" panose="020B0604020202020204" pitchFamily="34" charset="0"/>
                    <a:cs typeface="Arial" panose="020B0604020202020204" pitchFamily="34" charset="0"/>
                  </a:rPr>
                  <a:t>BL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0" name="组合 19">
              <a:extLst>
                <a:ext uri="{FF2B5EF4-FFF2-40B4-BE49-F238E27FC236}">
                  <a16:creationId xmlns:a16="http://schemas.microsoft.com/office/drawing/2014/main" id="{BD20A45F-1079-4513-8CC8-223EC847724E}"/>
                </a:ext>
              </a:extLst>
            </p:cNvPr>
            <p:cNvGrpSpPr/>
            <p:nvPr/>
          </p:nvGrpSpPr>
          <p:grpSpPr>
            <a:xfrm>
              <a:off x="4118473" y="1976353"/>
              <a:ext cx="3964153" cy="3569221"/>
              <a:chOff x="4118473" y="1976353"/>
              <a:chExt cx="3964153" cy="3569221"/>
            </a:xfrm>
          </p:grpSpPr>
          <p:grpSp>
            <p:nvGrpSpPr>
              <p:cNvPr id="3" name="组合 2">
                <a:extLst>
                  <a:ext uri="{FF2B5EF4-FFF2-40B4-BE49-F238E27FC236}">
                    <a16:creationId xmlns:a16="http://schemas.microsoft.com/office/drawing/2014/main" id="{9F7C8280-ACF0-4CC3-B0FC-1C0F85D44DC6}"/>
                  </a:ext>
                </a:extLst>
              </p:cNvPr>
              <p:cNvGrpSpPr/>
              <p:nvPr/>
            </p:nvGrpSpPr>
            <p:grpSpPr>
              <a:xfrm>
                <a:off x="4118473" y="1976353"/>
                <a:ext cx="3964153" cy="2939732"/>
                <a:chOff x="4118473" y="1976353"/>
                <a:chExt cx="3964153" cy="2939732"/>
              </a:xfrm>
            </p:grpSpPr>
            <p:pic>
              <p:nvPicPr>
                <p:cNvPr id="13" name="图片 12">
                  <a:extLst>
                    <a:ext uri="{FF2B5EF4-FFF2-40B4-BE49-F238E27FC236}">
                      <a16:creationId xmlns:a16="http://schemas.microsoft.com/office/drawing/2014/main" id="{B4908CF0-9F33-4C77-9102-A58353A2F18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118473" y="1982304"/>
                  <a:ext cx="3940351" cy="2933781"/>
                </a:xfrm>
                <a:prstGeom prst="rect">
                  <a:avLst/>
                </a:prstGeom>
              </p:spPr>
            </p:pic>
            <p:grpSp>
              <p:nvGrpSpPr>
                <p:cNvPr id="14" name="组合 13">
                  <a:extLst>
                    <a:ext uri="{FF2B5EF4-FFF2-40B4-BE49-F238E27FC236}">
                      <a16:creationId xmlns:a16="http://schemas.microsoft.com/office/drawing/2014/main" id="{5B5BD745-DAD6-4017-8C59-B928F6A0668E}"/>
                    </a:ext>
                  </a:extLst>
                </p:cNvPr>
                <p:cNvGrpSpPr/>
                <p:nvPr/>
              </p:nvGrpSpPr>
              <p:grpSpPr>
                <a:xfrm>
                  <a:off x="5529733" y="1976353"/>
                  <a:ext cx="2552893" cy="1305210"/>
                  <a:chOff x="2660072" y="372510"/>
                  <a:chExt cx="3962400" cy="2025845"/>
                </a:xfrm>
              </p:grpSpPr>
              <p:cxnSp>
                <p:nvCxnSpPr>
                  <p:cNvPr id="16" name="直接连接符 15">
                    <a:extLst>
                      <a:ext uri="{FF2B5EF4-FFF2-40B4-BE49-F238E27FC236}">
                        <a16:creationId xmlns:a16="http://schemas.microsoft.com/office/drawing/2014/main" id="{C6C2A3AB-7142-4136-AA8D-C7B9A37EC92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660072" y="408824"/>
                    <a:ext cx="2092036" cy="1971689"/>
                  </a:xfrm>
                  <a:prstGeom prst="line">
                    <a:avLst/>
                  </a:prstGeom>
                  <a:ln w="22225">
                    <a:solidFill>
                      <a:schemeClr val="tx1"/>
                    </a:solidFill>
                    <a:prstDash val="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7" name="直接连接符 16">
                    <a:extLst>
                      <a:ext uri="{FF2B5EF4-FFF2-40B4-BE49-F238E27FC236}">
                        <a16:creationId xmlns:a16="http://schemas.microsoft.com/office/drawing/2014/main" id="{A22DCA78-02CB-4452-B3F6-664FF33F1AD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761344" y="2398355"/>
                    <a:ext cx="1861128" cy="0"/>
                  </a:xfrm>
                  <a:prstGeom prst="line">
                    <a:avLst/>
                  </a:prstGeom>
                  <a:ln w="22225">
                    <a:solidFill>
                      <a:schemeClr val="tx1"/>
                    </a:solidFill>
                    <a:prstDash val="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8" name="直接连接符 17">
                    <a:extLst>
                      <a:ext uri="{FF2B5EF4-FFF2-40B4-BE49-F238E27FC236}">
                        <a16:creationId xmlns:a16="http://schemas.microsoft.com/office/drawing/2014/main" id="{F0315D00-8485-4A4E-BBC9-9E0CD4F1CF8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660072" y="381116"/>
                    <a:ext cx="3962400" cy="0"/>
                  </a:xfrm>
                  <a:prstGeom prst="line">
                    <a:avLst/>
                  </a:prstGeom>
                  <a:ln w="22225">
                    <a:solidFill>
                      <a:schemeClr val="tx1"/>
                    </a:solidFill>
                    <a:prstDash val="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" name="直接连接符 18">
                    <a:extLst>
                      <a:ext uri="{FF2B5EF4-FFF2-40B4-BE49-F238E27FC236}">
                        <a16:creationId xmlns:a16="http://schemas.microsoft.com/office/drawing/2014/main" id="{BCC4E676-FCEB-4AB8-8BBA-3415324E6A4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6622472" y="372510"/>
                    <a:ext cx="0" cy="2008003"/>
                  </a:xfrm>
                  <a:prstGeom prst="line">
                    <a:avLst/>
                  </a:prstGeom>
                  <a:ln w="22225">
                    <a:solidFill>
                      <a:schemeClr val="tx1"/>
                    </a:solidFill>
                    <a:prstDash val="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15" name="文本框 14">
                <a:extLst>
                  <a:ext uri="{FF2B5EF4-FFF2-40B4-BE49-F238E27FC236}">
                    <a16:creationId xmlns:a16="http://schemas.microsoft.com/office/drawing/2014/main" id="{3E4B182B-8A15-4240-B80D-17CCD24CCC4E}"/>
                  </a:ext>
                </a:extLst>
              </p:cNvPr>
              <p:cNvSpPr txBox="1"/>
              <p:nvPr/>
            </p:nvSpPr>
            <p:spPr>
              <a:xfrm>
                <a:off x="4954245" y="5185096"/>
                <a:ext cx="931233" cy="36047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dirty="0">
                    <a:latin typeface="Arial" panose="020B0604020202020204" pitchFamily="34" charset="0"/>
                    <a:cs typeface="Arial" panose="020B0604020202020204" pitchFamily="34" charset="0"/>
                  </a:rPr>
                  <a:t>24-EBL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8" name="组合 27">
              <a:extLst>
                <a:ext uri="{FF2B5EF4-FFF2-40B4-BE49-F238E27FC236}">
                  <a16:creationId xmlns:a16="http://schemas.microsoft.com/office/drawing/2014/main" id="{E202C065-F5E3-4BDC-8D3A-3303AC296E08}"/>
                </a:ext>
              </a:extLst>
            </p:cNvPr>
            <p:cNvGrpSpPr/>
            <p:nvPr/>
          </p:nvGrpSpPr>
          <p:grpSpPr>
            <a:xfrm>
              <a:off x="7605902" y="1968439"/>
              <a:ext cx="3993609" cy="3629228"/>
              <a:chOff x="3042811" y="1095049"/>
              <a:chExt cx="6143321" cy="5582798"/>
            </a:xfrm>
          </p:grpSpPr>
          <p:pic>
            <p:nvPicPr>
              <p:cNvPr id="29" name="图片 28">
                <a:extLst>
                  <a:ext uri="{FF2B5EF4-FFF2-40B4-BE49-F238E27FC236}">
                    <a16:creationId xmlns:a16="http://schemas.microsoft.com/office/drawing/2014/main" id="{7AD3C9C7-10F4-4B68-BA5B-2B5FDAA02EB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042811" y="1095049"/>
                <a:ext cx="6106377" cy="4667902"/>
              </a:xfrm>
              <a:prstGeom prst="rect">
                <a:avLst/>
              </a:prstGeom>
            </p:spPr>
          </p:pic>
          <p:grpSp>
            <p:nvGrpSpPr>
              <p:cNvPr id="30" name="组合 29">
                <a:extLst>
                  <a:ext uri="{FF2B5EF4-FFF2-40B4-BE49-F238E27FC236}">
                    <a16:creationId xmlns:a16="http://schemas.microsoft.com/office/drawing/2014/main" id="{28DFAAF5-8B2F-4652-BFAE-59234380C7C8}"/>
                  </a:ext>
                </a:extLst>
              </p:cNvPr>
              <p:cNvGrpSpPr/>
              <p:nvPr/>
            </p:nvGrpSpPr>
            <p:grpSpPr>
              <a:xfrm>
                <a:off x="5223732" y="1166208"/>
                <a:ext cx="3962400" cy="2035711"/>
                <a:chOff x="2660072" y="362644"/>
                <a:chExt cx="3962400" cy="2035711"/>
              </a:xfrm>
            </p:grpSpPr>
            <p:cxnSp>
              <p:nvCxnSpPr>
                <p:cNvPr id="32" name="直接连接符 31">
                  <a:extLst>
                    <a:ext uri="{FF2B5EF4-FFF2-40B4-BE49-F238E27FC236}">
                      <a16:creationId xmlns:a16="http://schemas.microsoft.com/office/drawing/2014/main" id="{6BFEF6D2-D2C6-43EA-8518-E43C156E816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660072" y="408824"/>
                  <a:ext cx="2092036" cy="1971689"/>
                </a:xfrm>
                <a:prstGeom prst="line">
                  <a:avLst/>
                </a:prstGeom>
                <a:ln w="22225">
                  <a:solidFill>
                    <a:schemeClr val="tx1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3" name="直接连接符 32">
                  <a:extLst>
                    <a:ext uri="{FF2B5EF4-FFF2-40B4-BE49-F238E27FC236}">
                      <a16:creationId xmlns:a16="http://schemas.microsoft.com/office/drawing/2014/main" id="{FD981723-BFE7-424B-9816-622E1A6CE1C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761344" y="2398355"/>
                  <a:ext cx="1861128" cy="0"/>
                </a:xfrm>
                <a:prstGeom prst="line">
                  <a:avLst/>
                </a:prstGeom>
                <a:ln w="22225">
                  <a:solidFill>
                    <a:schemeClr val="tx1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4" name="直接连接符 33">
                  <a:extLst>
                    <a:ext uri="{FF2B5EF4-FFF2-40B4-BE49-F238E27FC236}">
                      <a16:creationId xmlns:a16="http://schemas.microsoft.com/office/drawing/2014/main" id="{502552F4-B480-4750-9A56-8D2965028E5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660072" y="362644"/>
                  <a:ext cx="3962400" cy="0"/>
                </a:xfrm>
                <a:prstGeom prst="line">
                  <a:avLst/>
                </a:prstGeom>
                <a:ln w="22225">
                  <a:solidFill>
                    <a:schemeClr val="tx1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5" name="直接连接符 34">
                  <a:extLst>
                    <a:ext uri="{FF2B5EF4-FFF2-40B4-BE49-F238E27FC236}">
                      <a16:creationId xmlns:a16="http://schemas.microsoft.com/office/drawing/2014/main" id="{5C2CE416-AC85-4805-A8AF-49B40DDED9B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622472" y="372510"/>
                  <a:ext cx="0" cy="2008003"/>
                </a:xfrm>
                <a:prstGeom prst="line">
                  <a:avLst/>
                </a:prstGeom>
                <a:ln w="22225">
                  <a:solidFill>
                    <a:schemeClr val="tx1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1" name="文本框 30">
                <a:extLst>
                  <a:ext uri="{FF2B5EF4-FFF2-40B4-BE49-F238E27FC236}">
                    <a16:creationId xmlns:a16="http://schemas.microsoft.com/office/drawing/2014/main" id="{086A97D2-760E-4868-B513-07965D3B37AB}"/>
                  </a:ext>
                </a:extLst>
              </p:cNvPr>
              <p:cNvSpPr txBox="1"/>
              <p:nvPr/>
            </p:nvSpPr>
            <p:spPr>
              <a:xfrm>
                <a:off x="4333279" y="6123329"/>
                <a:ext cx="1451760" cy="55451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dirty="0">
                    <a:latin typeface="Arial" panose="020B0604020202020204" pitchFamily="34" charset="0"/>
                    <a:cs typeface="Arial" panose="020B0604020202020204" pitchFamily="34" charset="0"/>
                  </a:rPr>
                  <a:t>28-HBL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36" name="文本框 35">
            <a:extLst>
              <a:ext uri="{FF2B5EF4-FFF2-40B4-BE49-F238E27FC236}">
                <a16:creationId xmlns:a16="http://schemas.microsoft.com/office/drawing/2014/main" id="{E138993E-DA7A-45C7-81D7-9DCD0103273D}"/>
              </a:ext>
            </a:extLst>
          </p:cNvPr>
          <p:cNvSpPr txBox="1"/>
          <p:nvPr/>
        </p:nvSpPr>
        <p:spPr>
          <a:xfrm>
            <a:off x="944610" y="5440722"/>
            <a:ext cx="1086639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Figure S1. Chemical structure of BL, 24-EBL and 28-HBL. The dashed boxes represent the side chain.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58091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>
            <a:extLst>
              <a:ext uri="{FF2B5EF4-FFF2-40B4-BE49-F238E27FC236}">
                <a16:creationId xmlns:a16="http://schemas.microsoft.com/office/drawing/2014/main" id="{BED7F58A-412F-C00E-D9B8-268B48A6B4FF}"/>
              </a:ext>
            </a:extLst>
          </p:cNvPr>
          <p:cNvGrpSpPr/>
          <p:nvPr/>
        </p:nvGrpSpPr>
        <p:grpSpPr>
          <a:xfrm>
            <a:off x="2788120" y="280001"/>
            <a:ext cx="6220709" cy="5380471"/>
            <a:chOff x="733270" y="226313"/>
            <a:chExt cx="7553480" cy="6533224"/>
          </a:xfrm>
        </p:grpSpPr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A5CA45D5-4486-4498-A69D-E82C3B98F67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733270" y="226313"/>
              <a:ext cx="7553480" cy="6533224"/>
            </a:xfrm>
            <a:prstGeom prst="rect">
              <a:avLst/>
            </a:prstGeom>
          </p:spPr>
        </p:pic>
        <p:sp>
          <p:nvSpPr>
            <p:cNvPr id="2" name="文本框 1">
              <a:extLst>
                <a:ext uri="{FF2B5EF4-FFF2-40B4-BE49-F238E27FC236}">
                  <a16:creationId xmlns:a16="http://schemas.microsoft.com/office/drawing/2014/main" id="{59BD0961-382F-443B-B5DE-C7B4F4E44E71}"/>
                </a:ext>
              </a:extLst>
            </p:cNvPr>
            <p:cNvSpPr txBox="1"/>
            <p:nvPr/>
          </p:nvSpPr>
          <p:spPr>
            <a:xfrm>
              <a:off x="4238941" y="4263576"/>
              <a:ext cx="804270" cy="411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Y597</a:t>
              </a:r>
              <a:endParaRPr lang="zh-CN" altLang="en-US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3484BF4C-333A-4840-9104-6C742E61B0F0}"/>
                </a:ext>
              </a:extLst>
            </p:cNvPr>
            <p:cNvSpPr txBox="1"/>
            <p:nvPr/>
          </p:nvSpPr>
          <p:spPr>
            <a:xfrm>
              <a:off x="4647011" y="5159556"/>
              <a:ext cx="790645" cy="411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615</a:t>
              </a:r>
              <a:endParaRPr lang="zh-CN" altLang="en-US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1AA2289F-39B8-4EC3-8034-0C55E9F2BF02}"/>
                </a:ext>
              </a:extLst>
            </p:cNvPr>
            <p:cNvSpPr txBox="1"/>
            <p:nvPr/>
          </p:nvSpPr>
          <p:spPr>
            <a:xfrm>
              <a:off x="5125953" y="4314285"/>
              <a:ext cx="555125" cy="4110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L</a:t>
              </a:r>
              <a:endParaRPr lang="zh-CN" altLang="en-US" sz="1600" b="1" baseline="30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0" name="文本框 9">
            <a:extLst>
              <a:ext uri="{FF2B5EF4-FFF2-40B4-BE49-F238E27FC236}">
                <a16:creationId xmlns:a16="http://schemas.microsoft.com/office/drawing/2014/main" id="{F52C3E80-449A-A8D8-13A5-AF57F8B65942}"/>
              </a:ext>
            </a:extLst>
          </p:cNvPr>
          <p:cNvSpPr txBox="1"/>
          <p:nvPr/>
        </p:nvSpPr>
        <p:spPr>
          <a:xfrm>
            <a:off x="707572" y="5934670"/>
            <a:ext cx="11097251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Figure S2. A crystal structure of Arabidopsis BRI1. </a:t>
            </a:r>
            <a:r>
              <a:rPr lang="en-US" altLang="zh-CN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The green dots denote the conserved Tyr</a:t>
            </a:r>
            <a:r>
              <a:rPr lang="en-US" altLang="zh-CN" kern="100" baseline="30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597</a:t>
            </a:r>
            <a:r>
              <a:rPr lang="en-US" altLang="zh-CN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residue, while the light blue-colored dots represent Leu</a:t>
            </a:r>
            <a:r>
              <a:rPr lang="en-US" altLang="zh-CN" kern="100" baseline="300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615</a:t>
            </a:r>
            <a:r>
              <a:rPr lang="en-US" altLang="zh-CN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residue. The blue sticks denote </a:t>
            </a:r>
            <a:r>
              <a:rPr lang="en-US" altLang="zh-CN" kern="100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brassinolide</a:t>
            </a:r>
            <a:r>
              <a:rPr lang="en-US" altLang="zh-CN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(BL).</a:t>
            </a:r>
            <a:endParaRPr lang="zh-CN" altLang="zh-CN" kern="100" dirty="0">
              <a:effectLst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  <a:p>
            <a:pPr algn="just"/>
            <a:endParaRPr lang="zh-CN" altLang="zh-CN" kern="100" dirty="0">
              <a:effectLst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7692291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9D4DAAF5-5209-DFE2-1419-1D6923B3F146}"/>
              </a:ext>
            </a:extLst>
          </p:cNvPr>
          <p:cNvSpPr txBox="1"/>
          <p:nvPr/>
        </p:nvSpPr>
        <p:spPr>
          <a:xfrm>
            <a:off x="392918" y="4967266"/>
            <a:ext cx="11406164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Figure S3.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mino acid alignment of the island domain in various dicots and monocots. Symbols include:</a:t>
            </a:r>
            <a:r>
              <a:rPr lang="en-US" altLang="zh-CN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t, </a:t>
            </a:r>
            <a:r>
              <a:rPr lang="en-US" altLang="zh-CN" i="1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rabidopsis thaliana</a:t>
            </a:r>
            <a:r>
              <a:rPr lang="en-US" altLang="zh-CN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</a:t>
            </a:r>
            <a:r>
              <a:rPr lang="en-US" altLang="zh-CN" b="0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r, </a:t>
            </a:r>
            <a:r>
              <a:rPr lang="en-US" altLang="zh-CN" sz="18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Brassica </a:t>
            </a:r>
            <a:r>
              <a:rPr lang="en-US" altLang="zh-CN" sz="1800" i="1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rapa</a:t>
            </a:r>
            <a:r>
              <a:rPr lang="en-US" altLang="zh-CN" sz="1800" kern="100" dirty="0">
                <a:solidFill>
                  <a:srgbClr val="333333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; Rs, </a:t>
            </a:r>
            <a:r>
              <a:rPr lang="en-US" altLang="zh-CN" sz="18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Raphanus sativus</a:t>
            </a:r>
            <a:r>
              <a:rPr lang="en-US" altLang="zh-CN" sz="1800" kern="100" dirty="0">
                <a:solidFill>
                  <a:srgbClr val="333333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; </a:t>
            </a:r>
            <a:r>
              <a:rPr lang="en-US" altLang="zh-CN" b="0" i="0" dirty="0" err="1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r>
              <a:rPr lang="en-US" altLang="zh-CN" b="0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, </a:t>
            </a:r>
            <a:r>
              <a:rPr lang="en-US" altLang="zh-CN" b="0" i="1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olanum </a:t>
            </a:r>
            <a:r>
              <a:rPr lang="en-US" altLang="zh-CN" b="0" i="1" dirty="0" err="1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lycopersicum</a:t>
            </a:r>
            <a:r>
              <a:rPr lang="en-US" altLang="zh-CN" b="0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; Gm, </a:t>
            </a:r>
            <a:r>
              <a:rPr lang="en-US" altLang="zh-CN" sz="18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Glycine max</a:t>
            </a:r>
            <a:r>
              <a:rPr lang="en-US" altLang="zh-CN" sz="18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; Ah, </a:t>
            </a:r>
            <a:r>
              <a:rPr lang="en-US" altLang="zh-CN" sz="18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Arachis </a:t>
            </a:r>
            <a:r>
              <a:rPr lang="en-US" altLang="zh-CN" sz="1800" i="1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hypogaea</a:t>
            </a:r>
            <a:r>
              <a:rPr lang="en-US" altLang="zh-CN" sz="18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; Cp, </a:t>
            </a:r>
            <a:r>
              <a:rPr lang="en-US" altLang="zh-CN" sz="1800" i="1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arica</a:t>
            </a:r>
            <a:r>
              <a:rPr lang="en-US" altLang="zh-CN" sz="18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papaya</a:t>
            </a:r>
            <a:r>
              <a:rPr lang="en-US" altLang="zh-CN" sz="18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; Pt, </a:t>
            </a:r>
            <a:r>
              <a:rPr lang="en-US" altLang="zh-CN" sz="18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Populus </a:t>
            </a:r>
            <a:r>
              <a:rPr lang="en-US" altLang="zh-CN" sz="1800" i="1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trichocarpa</a:t>
            </a:r>
            <a:r>
              <a:rPr lang="en-US" altLang="zh-CN" sz="18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; Lu, </a:t>
            </a:r>
            <a:r>
              <a:rPr lang="en-US" altLang="zh-CN" sz="1800" i="1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Linum</a:t>
            </a:r>
            <a:r>
              <a:rPr lang="en-US" altLang="zh-CN" sz="18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800" i="1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usitatissimum</a:t>
            </a:r>
            <a:r>
              <a:rPr lang="en-US" altLang="zh-CN" sz="18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; </a:t>
            </a:r>
            <a:r>
              <a:rPr lang="en-US" altLang="zh-CN" sz="18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Pv</a:t>
            </a:r>
            <a:r>
              <a:rPr lang="en-US" altLang="zh-CN" sz="18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, </a:t>
            </a:r>
            <a:r>
              <a:rPr lang="en-US" altLang="zh-CN" sz="1800" b="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haseolus vulgaris; </a:t>
            </a:r>
            <a:r>
              <a:rPr lang="en-US" altLang="zh-CN" b="0" i="0" dirty="0" err="1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Vr</a:t>
            </a:r>
            <a:r>
              <a:rPr lang="en-US" altLang="zh-CN" b="0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zh-CN" sz="1800" b="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itis riparia</a:t>
            </a:r>
            <a:r>
              <a:rPr lang="en-US" altLang="zh-CN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 Ta, </a:t>
            </a:r>
            <a:r>
              <a:rPr lang="en-US" altLang="zh-CN" i="1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iticum </a:t>
            </a:r>
            <a:r>
              <a:rPr lang="en-US" altLang="zh-CN" i="1" dirty="0" err="1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estivum</a:t>
            </a:r>
            <a:r>
              <a:rPr lang="en-US" altLang="zh-CN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 Hv, </a:t>
            </a:r>
            <a:r>
              <a:rPr lang="en-US" altLang="zh-CN" i="1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ordeum vulgare</a:t>
            </a:r>
            <a:r>
              <a:rPr lang="en-US" altLang="zh-CN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 </a:t>
            </a:r>
            <a:r>
              <a:rPr lang="en-US" altLang="zh-CN" dirty="0" err="1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s</a:t>
            </a:r>
            <a:r>
              <a:rPr lang="en-US" altLang="zh-CN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 </a:t>
            </a:r>
            <a:r>
              <a:rPr lang="en-US" altLang="zh-CN" i="1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ryza sativa</a:t>
            </a:r>
            <a:r>
              <a:rPr lang="en-US" altLang="zh-CN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 </a:t>
            </a:r>
            <a:r>
              <a:rPr lang="en-US" altLang="zh-CN" dirty="0" err="1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Zm</a:t>
            </a:r>
            <a:r>
              <a:rPr lang="en-US" altLang="zh-CN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 </a:t>
            </a:r>
            <a:r>
              <a:rPr lang="en-US" altLang="zh-CN" i="1" dirty="0" err="1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Zea</a:t>
            </a:r>
            <a:r>
              <a:rPr lang="en-US" altLang="zh-CN" i="1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ays</a:t>
            </a:r>
            <a:r>
              <a:rPr lang="en-US" altLang="zh-CN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 Sb</a:t>
            </a:r>
            <a:r>
              <a:rPr lang="en-US" altLang="zh-CN" b="0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, </a:t>
            </a:r>
            <a:r>
              <a:rPr lang="en-US" altLang="zh-CN" b="0" i="1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orghum bicolor</a:t>
            </a:r>
            <a:r>
              <a:rPr lang="en-US" altLang="zh-CN" b="0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; Si, </a:t>
            </a:r>
            <a:r>
              <a:rPr lang="en-US" altLang="zh-CN" b="0" i="1" dirty="0" err="1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etaria</a:t>
            </a:r>
            <a:r>
              <a:rPr lang="en-US" altLang="zh-CN" b="0" i="1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b="0" i="1" dirty="0" err="1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italica</a:t>
            </a:r>
            <a:r>
              <a:rPr lang="en-US" altLang="zh-CN" b="0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; Ac, </a:t>
            </a:r>
            <a:r>
              <a:rPr lang="en-US" altLang="zh-CN" sz="1800" b="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anas comosus</a:t>
            </a:r>
            <a:r>
              <a:rPr lang="en-US" altLang="zh-CN" sz="1800" b="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 Cn, </a:t>
            </a:r>
            <a:r>
              <a:rPr lang="en-US" altLang="zh-CN" sz="1800" b="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cos nucifera</a:t>
            </a:r>
            <a:r>
              <a:rPr lang="en-US" altLang="zh-CN" sz="1800" b="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 </a:t>
            </a:r>
            <a:r>
              <a:rPr lang="en-US" altLang="zh-CN" b="0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a, </a:t>
            </a:r>
            <a:r>
              <a:rPr lang="en-US" altLang="zh-CN" sz="1800" b="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usa acuminata</a:t>
            </a:r>
            <a:r>
              <a:rPr lang="en-US" altLang="zh-CN" b="0" i="0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zh-CN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The black asterisks indicate the conser</a:t>
            </a:r>
            <a:r>
              <a:rPr lang="en-US" altLang="zh-CN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ved Tyr and Leu</a:t>
            </a:r>
            <a:r>
              <a:rPr lang="en-US" altLang="zh-CN" kern="10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resi</a:t>
            </a:r>
            <a:r>
              <a:rPr lang="en-US" altLang="zh-CN" kern="1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dues in the island domain.</a:t>
            </a:r>
            <a:r>
              <a:rPr lang="en-US" altLang="zh-CN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1" name="图片 40">
            <a:extLst>
              <a:ext uri="{FF2B5EF4-FFF2-40B4-BE49-F238E27FC236}">
                <a16:creationId xmlns:a16="http://schemas.microsoft.com/office/drawing/2014/main" id="{B618EB2E-A50E-4D95-ECCA-E2B7B73BDB5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0607" y="389843"/>
            <a:ext cx="10015621" cy="472982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5304943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格 2">
            <a:extLst>
              <a:ext uri="{FF2B5EF4-FFF2-40B4-BE49-F238E27FC236}">
                <a16:creationId xmlns:a16="http://schemas.microsoft.com/office/drawing/2014/main" id="{E0B5B176-B090-4BC9-746A-783E55D776F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74509926"/>
              </p:ext>
            </p:extLst>
          </p:nvPr>
        </p:nvGraphicFramePr>
        <p:xfrm>
          <a:off x="2775772" y="1622563"/>
          <a:ext cx="6930359" cy="3309561"/>
        </p:xfrm>
        <a:graphic>
          <a:graphicData uri="http://schemas.openxmlformats.org/drawingml/2006/table">
            <a:tbl>
              <a:tblPr firstRow="1" firstCol="1" bandRow="1"/>
              <a:tblGrid>
                <a:gridCol w="2635127">
                  <a:extLst>
                    <a:ext uri="{9D8B030D-6E8A-4147-A177-3AD203B41FA5}">
                      <a16:colId xmlns:a16="http://schemas.microsoft.com/office/drawing/2014/main" val="2996228217"/>
                    </a:ext>
                  </a:extLst>
                </a:gridCol>
                <a:gridCol w="4295232">
                  <a:extLst>
                    <a:ext uri="{9D8B030D-6E8A-4147-A177-3AD203B41FA5}">
                      <a16:colId xmlns:a16="http://schemas.microsoft.com/office/drawing/2014/main" val="351987136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8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Primer</a:t>
                      </a:r>
                      <a:endParaRPr lang="zh-CN" sz="24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8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equence</a:t>
                      </a:r>
                      <a:endParaRPr lang="zh-CN" sz="24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829283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8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ctin F</a:t>
                      </a:r>
                      <a:endParaRPr lang="zh-CN" sz="24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8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GAAGGATCTGTACGGTAAC</a:t>
                      </a:r>
                      <a:endParaRPr lang="zh-CN" sz="24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9760169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8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ctin R</a:t>
                      </a:r>
                      <a:endParaRPr lang="zh-CN" sz="24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8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GACCTGCCTCATCATAACT</a:t>
                      </a:r>
                      <a:endParaRPr lang="zh-CN" sz="24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4096272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8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PD-QPCR-F</a:t>
                      </a:r>
                      <a:endParaRPr lang="zh-CN" sz="24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800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CTCAACTCAAGGAAGAGCA</a:t>
                      </a:r>
                      <a:endParaRPr lang="zh-CN" sz="24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0166141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8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PD-QPCR-R</a:t>
                      </a:r>
                      <a:endParaRPr lang="zh-CN" sz="24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8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AACCTTTGATCTCAACATCCGTC</a:t>
                      </a:r>
                      <a:endParaRPr lang="zh-CN" sz="24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5877245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8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WF4-QPCR-F</a:t>
                      </a:r>
                      <a:endParaRPr lang="zh-CN" sz="24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8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ATTGCTCTCGCTATCTTCTTC</a:t>
                      </a:r>
                      <a:endParaRPr lang="zh-CN" sz="24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715159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8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WF4-QPCR-R</a:t>
                      </a:r>
                      <a:endParaRPr lang="zh-CN" sz="24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8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ACTCTCCTAGTTCCTTCTTGG</a:t>
                      </a:r>
                      <a:endParaRPr lang="zh-CN" sz="24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2536164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8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AUR_AC1-QPCR-F</a:t>
                      </a:r>
                      <a:endParaRPr lang="zh-CN" sz="24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800" kern="10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TGTTGAGTAAATCTGAGGAAGAG</a:t>
                      </a:r>
                      <a:endParaRPr lang="zh-CN" sz="24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7638439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8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AUR_AC1-QPCR-R</a:t>
                      </a:r>
                      <a:endParaRPr lang="zh-CN" sz="2400" kern="10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800" kern="100" dirty="0"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TGTATCTGAGATGTGACTGTG</a:t>
                      </a:r>
                      <a:endParaRPr lang="zh-CN" sz="2400" kern="100" dirty="0"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20291694"/>
                  </a:ext>
                </a:extLst>
              </a:tr>
            </a:tbl>
          </a:graphicData>
        </a:graphic>
      </p:graphicFrame>
      <p:sp>
        <p:nvSpPr>
          <p:cNvPr id="5" name="文本框 4">
            <a:extLst>
              <a:ext uri="{FF2B5EF4-FFF2-40B4-BE49-F238E27FC236}">
                <a16:creationId xmlns:a16="http://schemas.microsoft.com/office/drawing/2014/main" id="{5836F2B0-94F0-626A-E6BE-44ED520892A2}"/>
              </a:ext>
            </a:extLst>
          </p:cNvPr>
          <p:cNvSpPr txBox="1"/>
          <p:nvPr/>
        </p:nvSpPr>
        <p:spPr>
          <a:xfrm>
            <a:off x="3848369" y="1082278"/>
            <a:ext cx="609724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kern="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Table S1. Primers used for RT-qPCR</a:t>
            </a:r>
            <a:r>
              <a:rPr lang="en-US" altLang="zh-CN" kern="0" dirty="0"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.</a:t>
            </a:r>
            <a:endParaRPr lang="zh-CN" altLang="zh-CN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506874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9</TotalTime>
  <Words>229</Words>
  <Application>Microsoft Office PowerPoint</Application>
  <PresentationFormat>宽屏</PresentationFormat>
  <Paragraphs>29</Paragraphs>
  <Slides>4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8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ao Juan</dc:creator>
  <cp:lastModifiedBy>Mao Juan</cp:lastModifiedBy>
  <cp:revision>2</cp:revision>
  <dcterms:created xsi:type="dcterms:W3CDTF">2023-04-05T07:56:27Z</dcterms:created>
  <dcterms:modified xsi:type="dcterms:W3CDTF">2023-04-15T23:01:55Z</dcterms:modified>
</cp:coreProperties>
</file>